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5" autoAdjust="0"/>
    <p:restoredTop sz="94660"/>
  </p:normalViewPr>
  <p:slideViewPr>
    <p:cSldViewPr snapToGrid="0" showGuides="1">
      <p:cViewPr varScale="1">
        <p:scale>
          <a:sx n="47" d="100"/>
          <a:sy n="47" d="100"/>
        </p:scale>
        <p:origin x="832" y="4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B9B872-8CF4-47C9-8208-486AD01EBA33}" type="datetimeFigureOut">
              <a:rPr lang="en-US" smtClean="0"/>
              <a:t>3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92B89-4615-4AD7-BB9D-0F19135F92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65564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B9B872-8CF4-47C9-8208-486AD01EBA33}" type="datetimeFigureOut">
              <a:rPr lang="en-US" smtClean="0"/>
              <a:t>3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92B89-4615-4AD7-BB9D-0F19135F92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64988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B9B872-8CF4-47C9-8208-486AD01EBA33}" type="datetimeFigureOut">
              <a:rPr lang="en-US" smtClean="0"/>
              <a:t>3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92B89-4615-4AD7-BB9D-0F19135F92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93462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B9B872-8CF4-47C9-8208-486AD01EBA33}" type="datetimeFigureOut">
              <a:rPr lang="en-US" smtClean="0"/>
              <a:t>3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92B89-4615-4AD7-BB9D-0F19135F92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38441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B9B872-8CF4-47C9-8208-486AD01EBA33}" type="datetimeFigureOut">
              <a:rPr lang="en-US" smtClean="0"/>
              <a:t>3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92B89-4615-4AD7-BB9D-0F19135F92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04163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B9B872-8CF4-47C9-8208-486AD01EBA33}" type="datetimeFigureOut">
              <a:rPr lang="en-US" smtClean="0"/>
              <a:t>3/2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92B89-4615-4AD7-BB9D-0F19135F92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98343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B9B872-8CF4-47C9-8208-486AD01EBA33}" type="datetimeFigureOut">
              <a:rPr lang="en-US" smtClean="0"/>
              <a:t>3/22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92B89-4615-4AD7-BB9D-0F19135F92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69029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B9B872-8CF4-47C9-8208-486AD01EBA33}" type="datetimeFigureOut">
              <a:rPr lang="en-US" smtClean="0"/>
              <a:t>3/22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92B89-4615-4AD7-BB9D-0F19135F92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01185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B9B872-8CF4-47C9-8208-486AD01EBA33}" type="datetimeFigureOut">
              <a:rPr lang="en-US" smtClean="0"/>
              <a:t>3/22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92B89-4615-4AD7-BB9D-0F19135F92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90473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B9B872-8CF4-47C9-8208-486AD01EBA33}" type="datetimeFigureOut">
              <a:rPr lang="en-US" smtClean="0"/>
              <a:t>3/2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92B89-4615-4AD7-BB9D-0F19135F92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61857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B9B872-8CF4-47C9-8208-486AD01EBA33}" type="datetimeFigureOut">
              <a:rPr lang="en-US" smtClean="0"/>
              <a:t>3/2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92B89-4615-4AD7-BB9D-0F19135F92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90684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B9B872-8CF4-47C9-8208-486AD01EBA33}" type="datetimeFigureOut">
              <a:rPr lang="en-US" smtClean="0"/>
              <a:t>3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192B89-4615-4AD7-BB9D-0F19135F92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8966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86" name="Picture 78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3286" y="336187"/>
            <a:ext cx="4388714" cy="2611441"/>
          </a:xfrm>
          <a:prstGeom prst="rect">
            <a:avLst/>
          </a:prstGeom>
        </p:spPr>
      </p:pic>
      <p:pic>
        <p:nvPicPr>
          <p:cNvPr id="787" name="Picture 78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72000" y="336186"/>
            <a:ext cx="4387494" cy="2611441"/>
          </a:xfrm>
          <a:prstGeom prst="rect">
            <a:avLst/>
          </a:prstGeom>
        </p:spPr>
      </p:pic>
      <p:sp>
        <p:nvSpPr>
          <p:cNvPr id="788" name="TextBox 787"/>
          <p:cNvSpPr txBox="1"/>
          <p:nvPr/>
        </p:nvSpPr>
        <p:spPr>
          <a:xfrm>
            <a:off x="322729" y="4087906"/>
            <a:ext cx="7399635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* Concentration in GK and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Wistar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are statistically significant for that sex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† Concentration in male and female are statistically significant for that phenotype (compares to corresponding moiety in panels A &amp; B).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§ The ANOVA interaction term is statistically significant (compares corresponding moiety in panels A &amp; B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057383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4</TotalTime>
  <Words>53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MI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imothy Whitehead</dc:creator>
  <cp:lastModifiedBy>Kooresh Shoghi</cp:lastModifiedBy>
  <cp:revision>32</cp:revision>
  <dcterms:created xsi:type="dcterms:W3CDTF">2016-03-22T18:02:31Z</dcterms:created>
  <dcterms:modified xsi:type="dcterms:W3CDTF">2016-03-23T04:38:38Z</dcterms:modified>
</cp:coreProperties>
</file>